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5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418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417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760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439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2358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092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0762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032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283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7268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773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619F23-8DCB-4E7C-A7F0-F71351ADFBED}" type="datetimeFigureOut">
              <a:rPr kumimoji="1" lang="ja-JP" altLang="en-US" smtClean="0"/>
              <a:t>2016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B4D5B-9DF3-4D5B-8425-8ABF4B599A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314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8202548"/>
              </p:ext>
            </p:extLst>
          </p:nvPr>
        </p:nvGraphicFramePr>
        <p:xfrm>
          <a:off x="2760526" y="792479"/>
          <a:ext cx="6699521" cy="5760720"/>
        </p:xfrm>
        <a:graphic>
          <a:graphicData uri="http://schemas.openxmlformats.org/drawingml/2006/table">
            <a:tbl>
              <a:tblPr firstRow="1" firstCol="1" bandRow="1"/>
              <a:tblGrid>
                <a:gridCol w="315316"/>
                <a:gridCol w="1384732"/>
                <a:gridCol w="670523"/>
                <a:gridCol w="433084"/>
                <a:gridCol w="518563"/>
                <a:gridCol w="404592"/>
                <a:gridCol w="670523"/>
                <a:gridCol w="433084"/>
                <a:gridCol w="524261"/>
                <a:gridCol w="402693"/>
                <a:gridCol w="942150"/>
              </a:tblGrid>
              <a:tr h="410291">
                <a:tc>
                  <a:txBody>
                    <a:bodyPr/>
                    <a:lstStyle/>
                    <a:p>
                      <a:endParaRPr lang="ja-JP" sz="16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%DL</a:t>
                      </a:r>
                      <a:r>
                        <a:rPr lang="en-US" sz="16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CO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ja-JP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80%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ja-JP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80%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value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(n=25)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(n=70)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410291">
                <a:tc grid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cm depth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%HAA: 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7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3.1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8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1.3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49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6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7.6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7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6.2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14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5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.8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9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11</a:t>
                      </a:r>
                      <a:endParaRPr lang="ja-JP" sz="16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4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2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.5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13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0291">
                <a:tc grid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cm depth</a:t>
                      </a:r>
                      <a:endParaRPr lang="ja-JP" sz="16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%HAA: 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7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1.0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0.3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3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188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6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6.9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6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6.2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9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77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500H.U.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.8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.3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55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291"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&gt;-400H.U.</a:t>
                      </a:r>
                      <a:endParaRPr lang="ja-JP" sz="16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5 </a:t>
                      </a:r>
                      <a:r>
                        <a:rPr lang="ja-JP" sz="18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 dirty="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 dirty="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  <a:endParaRPr lang="ja-JP" sz="16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2 </a:t>
                      </a:r>
                      <a:r>
                        <a:rPr lang="ja-JP" sz="180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ja-JP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kern="100">
                          <a:effectLst/>
                          <a:latin typeface="Century" panose="020406040505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ja-JP" sz="16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60</a:t>
                      </a:r>
                      <a:endParaRPr lang="ja-JP" sz="16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102572" marR="10257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1226660" y="74895"/>
            <a:ext cx="976725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kern="1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S1 Table. 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Comparison of quantification using 3D-cMPR obtained with various depth and thresholds between normal and low diffusion capacity group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036394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35</Words>
  <Application>Microsoft Office PowerPoint</Application>
  <PresentationFormat>ワイド画面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yasu Umakoshi</dc:creator>
  <cp:lastModifiedBy>Hiroyasu Umakoshi</cp:lastModifiedBy>
  <cp:revision>4</cp:revision>
  <dcterms:created xsi:type="dcterms:W3CDTF">2016-02-25T13:56:06Z</dcterms:created>
  <dcterms:modified xsi:type="dcterms:W3CDTF">2016-03-16T13:39:06Z</dcterms:modified>
</cp:coreProperties>
</file>